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handoutMasterIdLst>
    <p:handoutMasterId r:id="rId4"/>
  </p:handoutMasterIdLst>
  <p:sldIdLst>
    <p:sldId id="398" r:id="rId2"/>
  </p:sldIdLst>
  <p:sldSz cx="12192000" cy="6858000"/>
  <p:notesSz cx="9928225" cy="67976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404" autoAdjust="0"/>
  </p:normalViewPr>
  <p:slideViewPr>
    <p:cSldViewPr snapToGrid="0">
      <p:cViewPr varScale="1">
        <p:scale>
          <a:sx n="80" d="100"/>
          <a:sy n="80" d="100"/>
        </p:scale>
        <p:origin x="58" y="22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5622594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07FB4-1BBF-45E7-839D-23EC12C90DF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5622594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DB775-D806-4765-93AE-1EB5168EE0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342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623700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4D560-1906-4008-84E6-2CA8AC7F4D7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49313"/>
            <a:ext cx="40767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92823" y="3271383"/>
            <a:ext cx="794258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3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623700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CBE8E6-A870-4E49-946C-A827C617A7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7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CBE8E6-A870-4E49-946C-A827C617A7B8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65597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CC285D0-E2CA-4372-8B20-4C1D8A5908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1B071ABB-53FE-4274-96A2-67E691EC3B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94E1497-FB67-421D-8252-051000DA4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C25BF68-4349-4AA0-8140-413B2A61E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10EF8DF-456A-4A9D-9BA9-8C57A0B68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1842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F0560A6-0B9D-4E36-83FB-1CFBCB474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A8516A8F-C42B-4EFA-A07D-0EBBCF763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79E5EA6-5A81-4675-9D0E-E8D165D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06F61DF-05D4-4896-A4B8-C1BE97777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C423BD3-AA2F-465B-BB1F-9C02B6E16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30741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E48251E2-E313-404D-96F6-DD01FC934C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9284E747-A2D6-4F36-B5E9-9680958A3E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DCDF270-C6B7-4408-8399-AC1E5249C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5463234-B209-432C-89B3-A8F519939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B0BE98D-4C1A-4871-92E6-30EC2E87D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09257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A7FA926-231A-4B21-A990-4B6E282A92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7A020BF-BD04-400B-9672-381564113C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76D9E05-55BB-4904-BD8E-D99C91746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313C300-35E2-4366-8259-BD9159403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43425FF-CDE0-44A5-9F9E-9F99B1D28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99749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43B3DC4-7D46-4A87-8C59-31E18C797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41A7E12B-4D3D-4401-8143-00BE7412FE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9DEA1A3-886B-4F88-838F-94EACF841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F04D842-C114-4363-A093-34922842A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1849924-C1AD-467C-8FA7-728BA36FE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00815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99F0519-F2B2-4F60-A732-C3C123B87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BB9BE637-C64F-40AD-B474-B40EEECF69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0C3B89B-153F-4B9E-AE0D-CE8D01E41C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9BE197D-20E0-4187-9C87-6FBD18081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25B00C9-FB83-4E68-BF08-5EBF34C6A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87C5B37-C46A-4A43-855C-75DA1CF06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7960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DF3B50E-27B0-46B9-A920-2882C5519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BD56E9C-32D4-4EFB-8A01-5CBE3B9E0C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D631C262-EBC4-40BC-A15A-4A85C51FF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FCBF0C99-4CB9-421C-943C-2BCFC4DF79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71C94B2F-9C82-41B9-ABE5-7566AD8861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F063D64F-DA6C-49D8-8F3C-9814F8306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4D0FCB33-312F-46D3-902A-76D670E2C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31E3AE77-258D-4173-94DB-1336676DA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115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D070DA8-B65F-43A9-876E-51EF818F4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660A2EB9-1BF8-4658-AF36-524B11A39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29EBB3C8-FC78-468D-A378-65BB9BC3B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1B89AA0-3644-4459-88A9-9E43F4DCD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76624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521F5C12-2D97-4871-99A4-627F6EF5C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E53B41A6-F5CA-4524-93A9-034E54134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95428567-564B-4C15-AD67-4578AEB54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84292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0E4C08-AE78-45B8-9A2E-068C8899D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CDBF7A5-F0EC-4B8C-9790-E4EB3768F6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DB1B5D0D-23B4-4610-B4DF-3C1589ACD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3B4DD800-6BB0-45DD-92DC-FEA39045E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035B0A9A-537A-4141-B059-A63EDF712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48114F8-8C2E-456C-B992-08D08FF33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0427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508ABDF-A6E2-4F87-A07D-AD26E5334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9F436D0C-EAED-4B91-8E79-5753D79C6B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78580AF0-0919-4FA7-840A-B6463C3BFE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B36CD61-1532-4BE9-8B27-42CB461D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FEED3FF-E2CA-4EFE-B201-4DA2A37AE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1AE24A1B-B0FD-4ADC-A132-2A590BE8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31249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521E63DA-FF73-4B76-ACA1-5BC619E62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F4064F7B-4647-4221-9C2E-4F60FC15E8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CF5CFAE-EA0A-4BE2-9CD8-3B0A681294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6334614-4F33-4C33-A19C-0B4BEA9D69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1102C74-8670-47A7-9532-897CF3A04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05212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"/>
          <p:cNvSpPr>
            <a:spLocks noChangeArrowheads="1"/>
          </p:cNvSpPr>
          <p:nvPr/>
        </p:nvSpPr>
        <p:spPr bwMode="auto">
          <a:xfrm>
            <a:off x="2623149" y="621774"/>
            <a:ext cx="623510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TW" b="1" dirty="0" smtClean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S1</a:t>
            </a:r>
            <a:r>
              <a:rPr lang="zh-TW" altLang="en-US" b="1" dirty="0" smtClean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TW" b="1" dirty="0" smtClean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kumimoji="0" lang="en-US" altLang="zh-TW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List of primers and their sequences used in this </a:t>
            </a:r>
            <a:r>
              <a:rPr kumimoji="0" lang="en-US" altLang="zh-TW" i="0" u="none" strike="noStrike" kern="1200" cap="none" spc="0" normalizeH="0" baseline="0" noProof="0" dirty="0" smtClean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study</a:t>
            </a:r>
            <a:endParaRPr kumimoji="0" lang="en-US" altLang="zh-TW" i="0" u="none" strike="noStrike" kern="1200" cap="none" spc="0" normalizeH="0" baseline="0" noProof="0" dirty="0">
              <a:ln>
                <a:noFill/>
              </a:ln>
              <a:solidFill>
                <a:srgbClr val="0000FF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1975449" y="1139619"/>
          <a:ext cx="7841411" cy="4709686"/>
        </p:xfrm>
        <a:graphic>
          <a:graphicData uri="http://schemas.openxmlformats.org/drawingml/2006/table">
            <a:tbl>
              <a:tblPr firstRow="1" firstCol="1" bandRow="1"/>
              <a:tblGrid>
                <a:gridCol w="238422">
                  <a:extLst>
                    <a:ext uri="{9D8B030D-6E8A-4147-A177-3AD203B41FA5}">
                      <a16:colId xmlns:a16="http://schemas.microsoft.com/office/drawing/2014/main" val="4099951160"/>
                    </a:ext>
                  </a:extLst>
                </a:gridCol>
                <a:gridCol w="1834988">
                  <a:extLst>
                    <a:ext uri="{9D8B030D-6E8A-4147-A177-3AD203B41FA5}">
                      <a16:colId xmlns:a16="http://schemas.microsoft.com/office/drawing/2014/main" val="3820187645"/>
                    </a:ext>
                  </a:extLst>
                </a:gridCol>
                <a:gridCol w="4061670">
                  <a:extLst>
                    <a:ext uri="{9D8B030D-6E8A-4147-A177-3AD203B41FA5}">
                      <a16:colId xmlns:a16="http://schemas.microsoft.com/office/drawing/2014/main" val="3405724612"/>
                    </a:ext>
                  </a:extLst>
                </a:gridCol>
                <a:gridCol w="1578686">
                  <a:extLst>
                    <a:ext uri="{9D8B030D-6E8A-4147-A177-3AD203B41FA5}">
                      <a16:colId xmlns:a16="http://schemas.microsoft.com/office/drawing/2014/main" val="3552586980"/>
                    </a:ext>
                  </a:extLst>
                </a:gridCol>
                <a:gridCol w="127645">
                  <a:extLst>
                    <a:ext uri="{9D8B030D-6E8A-4147-A177-3AD203B41FA5}">
                      <a16:colId xmlns:a16="http://schemas.microsoft.com/office/drawing/2014/main" val="188773820"/>
                    </a:ext>
                  </a:extLst>
                </a:gridCol>
              </a:tblGrid>
              <a:tr h="218519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me of primer sets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quences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ze of PCR product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705810"/>
                  </a:ext>
                </a:extLst>
              </a:tr>
              <a:tr h="218519">
                <a:tc gridSpan="3">
                  <a:txBody>
                    <a:bodyPr/>
                    <a:lstStyle/>
                    <a:p>
                      <a:pPr algn="l" font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 </a:t>
                      </a: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or </a:t>
                      </a:r>
                      <a:r>
                        <a:rPr lang="en-US" sz="1400" b="1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GA3ox1</a:t>
                      </a: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gene knockout - related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728185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GA3ox1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_sgRNA-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GCCGCCTACTTCAACTT</a:t>
                      </a:r>
                      <a:r>
                        <a:rPr lang="en-US" sz="1400" kern="1200"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1730755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GA3ox1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_sgRNA-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400" b="1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C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CGGAAGTTGAAGTAGGCGG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1198808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GA3ox1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_C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GCGAAAGAAATGGTCATGCCAA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8297336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GA3ox1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_C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GACGAGCAGGAACCCGCCC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8 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5956823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CAGGAAACAGCTATGA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4500823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CGGAAGTTGAAGTAGGCGG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444</a:t>
                      </a:r>
                      <a:r>
                        <a:rPr lang="en-US" sz="1400" kern="0">
                          <a:effectLst/>
                          <a:latin typeface="新細明體" panose="02020500000000000000" pitchFamily="18" charset="-12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14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1874987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hpt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-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CGGCCTCCAGAAGAAGATGTTG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313537"/>
                  </a:ext>
                </a:extLst>
              </a:tr>
              <a:tr h="218519">
                <a:tc gridSpan="2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400" i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hpt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-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AGCGAGAGCCTGACCTATTGC-3’</a:t>
                      </a:r>
                      <a:endParaRPr lang="zh-TW" sz="14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343 </a:t>
                      </a:r>
                      <a:r>
                        <a:rPr lang="en-US" sz="1400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Calibri" panose="020F0502020204030204" pitchFamily="34" charset="0"/>
                        </a:rPr>
                        <a:t>bp</a:t>
                      </a:r>
                      <a:endParaRPr lang="zh-TW" sz="14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8919151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For qRT-PC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288704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GAMYB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GTTTCCCCAGCACAAAGCA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70 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442996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GAMYB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CCCAGAAGCATTGCTATGGC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521834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TDR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GAGGTGCGTCAGGTGCAGGG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5228401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TDR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TGTCCCTCACCATGACGCGG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78 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884327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bHLH142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TCAACACCAAGATTCATTCGGG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1275298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bHLH142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R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AGCTAGCAACATAGAAACTTTCATCATATCG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49 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3964911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Actin-</a:t>
                      </a: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F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400" kern="100">
                          <a:effectLst/>
                          <a:latin typeface="Courier New" panose="02070309020205020404" pitchFamily="49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TTCCAACAGATGTGGATATCTAAGG</a:t>
                      </a: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’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3580986"/>
                  </a:ext>
                </a:extLst>
              </a:tr>
              <a:tr h="2622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 dirty="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i="1" kern="100" dirty="0" err="1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OsActin-</a:t>
                      </a:r>
                      <a:r>
                        <a:rPr lang="en-US" sz="1400" kern="100" dirty="0" err="1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qR</a:t>
                      </a:r>
                      <a:endParaRPr lang="zh-TW" sz="14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400" kern="100" dirty="0">
                          <a:effectLst/>
                          <a:latin typeface="Courier New" panose="02070309020205020404" pitchFamily="49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AGTACCGACACACGCCCAAC</a:t>
                      </a: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’</a:t>
                      </a:r>
                      <a:endParaRPr lang="zh-TW" sz="14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68 bp</a:t>
                      </a:r>
                      <a:endParaRPr lang="zh-TW" sz="14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zh-TW" sz="1400" kern="100" dirty="0"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88783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438055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36</TotalTime>
  <Words>125</Words>
  <Application>Microsoft Office PowerPoint</Application>
  <PresentationFormat>寬螢幕</PresentationFormat>
  <Paragraphs>75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Courier New</vt:lpstr>
      <vt:lpstr>Times New Roman</vt:lpstr>
      <vt:lpstr>1_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P-OsGA3ox1 T0 Screening</dc:title>
  <dc:creator>陳良築</dc:creator>
  <cp:lastModifiedBy>ljchen</cp:lastModifiedBy>
  <cp:revision>549</cp:revision>
  <cp:lastPrinted>2022-11-05T13:28:51Z</cp:lastPrinted>
  <dcterms:created xsi:type="dcterms:W3CDTF">2021-06-02T06:35:22Z</dcterms:created>
  <dcterms:modified xsi:type="dcterms:W3CDTF">2023-09-27T09:06:35Z</dcterms:modified>
</cp:coreProperties>
</file>